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9" autoAdjust="0"/>
    <p:restoredTop sz="94660"/>
  </p:normalViewPr>
  <p:slideViewPr>
    <p:cSldViewPr snapToGrid="0">
      <p:cViewPr varScale="1">
        <p:scale>
          <a:sx n="70" d="100"/>
          <a:sy n="70" d="100"/>
        </p:scale>
        <p:origin x="9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28255E-44B3-447B-BA52-8EC33CA4E1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258933-506C-4D13-822F-3096A62CE3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021B20-4AD4-408E-BD55-371D57A5C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DAB38A-3910-4C6C-9EDE-13BE403B9E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C6ADAA-1096-4870-B761-2D5C9D63F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176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C39D4-314C-4CF5-A5F1-1260D05FE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F60642-15D4-4F88-8B68-2FA354B55F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B125B1-2A14-4AF4-8AE7-45C3E27E5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77032-1B4D-4CAD-8D0A-5E593D5D1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0BA5CE-2454-494A-873B-EE78556584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289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802050-26DA-44FB-A5B0-2E8A207B10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1F1CAA-5191-4483-8546-9EF7A0E0DD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6F5A90-5180-4934-86DE-7B23D6B40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A0A3D-DE59-4FE7-9D58-9ABE5FFDA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06C71-CD98-431D-99DA-0EAC22451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212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F3C39-E5E5-4B3B-B32E-E59865A26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28E2D8-E59F-4DF3-BB9B-653B34F7CD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BC248-536B-445C-9DA5-D5C17D1DC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755AE9-3965-431D-8BBF-CACD65991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22F631-DA87-4EE2-A2EE-981388425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35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60BE7-C8F1-473D-8DE9-E231D0B17A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5C185E-4365-487E-93DE-7FE50734A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2D8EF-A3E4-4E02-9557-371EE0E73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115454-9027-484A-B551-34D0121E1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65017-6F41-4291-8314-2029AB34B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482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9EA077-04E7-41CD-9266-547596113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9AE8A3-AD29-4C07-A27E-9BDBB1F145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890FA9-A923-42B5-BE04-1742DEE0E6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738F24-13F5-4518-A975-C02F57EB8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08C5F8-2D1A-4AB3-A4E1-F993993B42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9B1ACD-C16F-4BD2-847D-C5AAF8AFF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498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E8AEA0-FBAE-4940-AD50-68EA633ED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D1766C-A203-44A9-85AC-D4795DA740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304C08-FFAD-4A76-BAFC-CAB79387DF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88DCC2-DFAD-4B25-A81E-3349033C28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86B5FD-6478-445F-B7BE-6D5E62A793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709A71-57A1-43B0-80F8-E783018D4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CBB049-E13C-418A-8004-70EBF8BD0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DEF387-808A-438F-A87B-72D0D21C3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502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7BACB-A1E1-43E5-B6E5-AB6017A45A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39A8659-665B-49E1-B467-8199E5EF0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7EEC03-04B4-4294-A1D3-327CD7AE7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11DBD2-EF8E-4A9E-A7AB-88016DD35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49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361205-BAC4-4441-B226-422F023BB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4C1B414-6353-4076-B040-2C5E55A1D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056C88-255B-40BB-8F87-0ED21E6CD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359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4DD5A-EBBA-43E7-B845-4754CF07E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4F90AA-E2D9-441F-9131-A2339F4225B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1E8B57-BA87-4457-B43A-D5B64BE838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EF9C0A-D933-47A7-AFF2-72AD74FE6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ABCA77-B4B6-493B-AE43-F61C1B800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DFE772-F16A-4950-9144-B9DD18865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29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2A5A04-2264-4CA9-BDC5-BF0618ABD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79C930-A0B5-4BCF-9774-68383E7597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7F7079-0309-4C0C-8028-5255ACD80C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74B5FE-FA7D-4FFE-908D-4ECE467F7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753D71-093E-440C-9122-B12AD824C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47CD80-3B05-4366-9A79-E88CBB660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515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0E69A8-BB99-470F-BC1B-FC493C0EB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7A7ED-8647-4406-B7D0-1EE8395A8A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FC1905-061B-467B-88FD-1EEC3D547F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02997-FE58-4300-AD23-CAC8BEBF1A4F}" type="datetimeFigureOut">
              <a:rPr lang="en-US" smtClean="0"/>
              <a:t>7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042D98-1A67-41A8-A62B-95C4F92B22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621B8-7B18-428C-B75B-1D2C9D4B9A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8502E-747A-4B6E-8548-C5A9C4F412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647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cid:2366432E-2F9A-4065-A8B6-7D622CC67A0B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A74CA627-9CF9-4876-9072-A80EA15569D5}"/>
              </a:ext>
            </a:extLst>
          </p:cNvPr>
          <p:cNvGrpSpPr/>
          <p:nvPr/>
        </p:nvGrpSpPr>
        <p:grpSpPr>
          <a:xfrm>
            <a:off x="1624649" y="1790250"/>
            <a:ext cx="7951214" cy="3028689"/>
            <a:chOff x="1324398" y="657486"/>
            <a:chExt cx="7951214" cy="3028689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3095650-3C86-47E3-879B-A7BF9E0E971B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4398" y="950221"/>
              <a:ext cx="1915253" cy="191525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B1AEC7F-A53A-4749-82D0-7266C89FCFAA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8583" y="978797"/>
              <a:ext cx="1885326" cy="188532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CEF9DE8-5700-446B-B409-EC92D326C725}"/>
                </a:ext>
              </a:extLst>
            </p:cNvPr>
            <p:cNvPicPr/>
            <p:nvPr/>
          </p:nvPicPr>
          <p:blipFill>
            <a:blip r:embed="rId4" r:link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72739" y="978797"/>
              <a:ext cx="1885326" cy="191390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0D442E5-99A4-4D12-897B-FF9327E77577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90286" y="978799"/>
              <a:ext cx="1885326" cy="19139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 Box 2">
              <a:extLst>
                <a:ext uri="{FF2B5EF4-FFF2-40B4-BE49-F238E27FC236}">
                  <a16:creationId xmlns:a16="http://schemas.microsoft.com/office/drawing/2014/main" id="{0829B1A8-C6DC-4C0E-86B4-6BDB050727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6686" y="657486"/>
              <a:ext cx="5943600" cy="29273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4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                                                                                                       B</a:t>
              </a:r>
            </a:p>
          </p:txBody>
        </p:sp>
        <p:sp>
          <p:nvSpPr>
            <p:cNvPr id="9" name="Text Box 2">
              <a:extLst>
                <a:ext uri="{FF2B5EF4-FFF2-40B4-BE49-F238E27FC236}">
                  <a16:creationId xmlns:a16="http://schemas.microsoft.com/office/drawing/2014/main" id="{DE7C7964-2F99-48DE-9440-B9382CD071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24398" y="2950521"/>
              <a:ext cx="7951214" cy="735654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. TEM assay was performed with </a:t>
              </a:r>
              <a:r>
                <a:rPr lang="en-US" sz="1400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rmCIRP</a:t>
              </a:r>
              <a:r>
                <a:rPr lang="en-US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treatment and transmigrated neutrophils were stained with [A] JAM-C (green color) and [B] ICAM-1 (red color) antibodies. JAM-C is expressed by the </a:t>
              </a:r>
              <a:r>
                <a:rPr lang="en-US" sz="1400" dirty="0" err="1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rogocytosed</a:t>
              </a:r>
              <a:r>
                <a:rPr lang="en-US" sz="14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neutrophil whereas ICAM-1 was seen in majority of the transmigrated neutrophils. 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015985EF-BDFD-47A7-9801-3FB40B3BBD47}"/>
              </a:ext>
            </a:extLst>
          </p:cNvPr>
          <p:cNvSpPr txBox="1"/>
          <p:nvPr/>
        </p:nvSpPr>
        <p:spPr>
          <a:xfrm>
            <a:off x="537503" y="119305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094068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rghese, Asha</dc:creator>
  <cp:lastModifiedBy>Varghese, Asha</cp:lastModifiedBy>
  <cp:revision>2</cp:revision>
  <dcterms:created xsi:type="dcterms:W3CDTF">2022-07-12T15:25:48Z</dcterms:created>
  <dcterms:modified xsi:type="dcterms:W3CDTF">2022-07-12T15:36:14Z</dcterms:modified>
</cp:coreProperties>
</file>